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6282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1103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4733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6247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782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6706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5462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3333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4902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3355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8734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0E3A3-4B3B-4F6B-A1A3-67E246414389}" type="datetimeFigureOut">
              <a:rPr lang="de-DE" smtClean="0"/>
              <a:t>03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64661-1E39-4C05-B469-A3BF1F60D1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5920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uppieren 20"/>
          <p:cNvGrpSpPr>
            <a:grpSpLocks noChangeAspect="1"/>
          </p:cNvGrpSpPr>
          <p:nvPr/>
        </p:nvGrpSpPr>
        <p:grpSpPr>
          <a:xfrm>
            <a:off x="1085850" y="265608"/>
            <a:ext cx="10925175" cy="6326784"/>
            <a:chOff x="-409575" y="32881"/>
            <a:chExt cx="12930208" cy="6603265"/>
          </a:xfrm>
        </p:grpSpPr>
        <p:grpSp>
          <p:nvGrpSpPr>
            <p:cNvPr id="22" name="Gruppieren 21"/>
            <p:cNvGrpSpPr/>
            <p:nvPr/>
          </p:nvGrpSpPr>
          <p:grpSpPr>
            <a:xfrm>
              <a:off x="-409575" y="32881"/>
              <a:ext cx="12930208" cy="6603265"/>
              <a:chOff x="-409575" y="32881"/>
              <a:chExt cx="12930208" cy="6603265"/>
            </a:xfrm>
          </p:grpSpPr>
          <p:grpSp>
            <p:nvGrpSpPr>
              <p:cNvPr id="24" name="Gruppieren 23"/>
              <p:cNvGrpSpPr/>
              <p:nvPr/>
            </p:nvGrpSpPr>
            <p:grpSpPr>
              <a:xfrm>
                <a:off x="515350" y="6314919"/>
                <a:ext cx="11378511" cy="321227"/>
                <a:chOff x="343900" y="6314919"/>
                <a:chExt cx="11378511" cy="321227"/>
              </a:xfrm>
            </p:grpSpPr>
            <p:sp>
              <p:nvSpPr>
                <p:cNvPr id="26" name="Rechteck 25"/>
                <p:cNvSpPr/>
                <p:nvPr/>
              </p:nvSpPr>
              <p:spPr>
                <a:xfrm>
                  <a:off x="343900" y="6391977"/>
                  <a:ext cx="270809" cy="166255"/>
                </a:xfrm>
                <a:prstGeom prst="rect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>
                  <a:solidFill>
                    <a:schemeClr val="accent1">
                      <a:lumMod val="20000"/>
                      <a:lumOff val="8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27" name="Textfeld 26"/>
                <p:cNvSpPr txBox="1"/>
                <p:nvPr/>
              </p:nvSpPr>
              <p:spPr>
                <a:xfrm>
                  <a:off x="568933" y="6314919"/>
                  <a:ext cx="1870976" cy="3212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reating</a:t>
                  </a:r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ysician</a:t>
                  </a:r>
                  <a:endParaRPr lang="de-D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Rechteck 27"/>
                <p:cNvSpPr/>
                <p:nvPr/>
              </p:nvSpPr>
              <p:spPr>
                <a:xfrm>
                  <a:off x="2305042" y="6391977"/>
                  <a:ext cx="249382" cy="166255"/>
                </a:xfrm>
                <a:prstGeom prst="rect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>
                  <a:solidFill>
                    <a:schemeClr val="accent1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29" name="Textfeld 28"/>
                <p:cNvSpPr txBox="1"/>
                <p:nvPr/>
              </p:nvSpPr>
              <p:spPr>
                <a:xfrm>
                  <a:off x="2544527" y="6314919"/>
                  <a:ext cx="111390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iagnosis</a:t>
                  </a:r>
                </a:p>
              </p:txBody>
            </p:sp>
            <p:sp>
              <p:nvSpPr>
                <p:cNvPr id="30" name="Rechteck 29"/>
                <p:cNvSpPr/>
                <p:nvPr/>
              </p:nvSpPr>
              <p:spPr>
                <a:xfrm>
                  <a:off x="3612912" y="6391977"/>
                  <a:ext cx="249382" cy="166255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1" name="Textfeld 30"/>
                <p:cNvSpPr txBox="1"/>
                <p:nvPr/>
              </p:nvSpPr>
              <p:spPr>
                <a:xfrm>
                  <a:off x="3862293" y="6314919"/>
                  <a:ext cx="170688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raindications</a:t>
                  </a:r>
                  <a:endParaRPr lang="de-D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Rechteck 31"/>
                <p:cNvSpPr/>
                <p:nvPr/>
              </p:nvSpPr>
              <p:spPr>
                <a:xfrm>
                  <a:off x="5519295" y="6391977"/>
                  <a:ext cx="249382" cy="166255"/>
                </a:xfrm>
                <a:prstGeom prst="rect">
                  <a:avLst/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3" name="Textfeld 32"/>
                <p:cNvSpPr txBox="1"/>
                <p:nvPr/>
              </p:nvSpPr>
              <p:spPr>
                <a:xfrm>
                  <a:off x="5759967" y="6314919"/>
                  <a:ext cx="170688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hrombolysis</a:t>
                  </a:r>
                  <a:endParaRPr lang="de-D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Rechteck 33"/>
                <p:cNvSpPr/>
                <p:nvPr/>
              </p:nvSpPr>
              <p:spPr>
                <a:xfrm>
                  <a:off x="7130523" y="6391977"/>
                  <a:ext cx="249382" cy="166255"/>
                </a:xfrm>
                <a:prstGeom prst="rect">
                  <a:avLst/>
                </a:prstGeom>
                <a:solidFill>
                  <a:srgbClr val="008000"/>
                </a:solidFill>
                <a:ln>
                  <a:solidFill>
                    <a:srgbClr val="008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5" name="Textfeld 34"/>
                <p:cNvSpPr txBox="1"/>
                <p:nvPr/>
              </p:nvSpPr>
              <p:spPr>
                <a:xfrm>
                  <a:off x="7379905" y="6314919"/>
                  <a:ext cx="110559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enefit</a:t>
                  </a:r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	</a:t>
                  </a:r>
                </a:p>
              </p:txBody>
            </p:sp>
            <p:sp>
              <p:nvSpPr>
                <p:cNvPr id="36" name="Rechteck 35"/>
                <p:cNvSpPr/>
                <p:nvPr/>
              </p:nvSpPr>
              <p:spPr>
                <a:xfrm>
                  <a:off x="8333491" y="6391977"/>
                  <a:ext cx="249382" cy="166255"/>
                </a:xfrm>
                <a:prstGeom prst="rect">
                  <a:avLst/>
                </a:prstGeom>
                <a:solidFill>
                  <a:srgbClr val="CC0000"/>
                </a:solidFill>
                <a:ln>
                  <a:solidFill>
                    <a:srgbClr val="CC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7" name="Textfeld 36"/>
                <p:cNvSpPr txBox="1"/>
                <p:nvPr/>
              </p:nvSpPr>
              <p:spPr>
                <a:xfrm>
                  <a:off x="8565455" y="6314919"/>
                  <a:ext cx="110559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isks</a:t>
                  </a:r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	</a:t>
                  </a:r>
                </a:p>
              </p:txBody>
            </p:sp>
            <p:sp>
              <p:nvSpPr>
                <p:cNvPr id="38" name="Rechteck 37"/>
                <p:cNvSpPr/>
                <p:nvPr/>
              </p:nvSpPr>
              <p:spPr>
                <a:xfrm>
                  <a:off x="9349520" y="6391977"/>
                  <a:ext cx="249382" cy="166255"/>
                </a:xfrm>
                <a:prstGeom prst="rect">
                  <a:avLst/>
                </a:prstGeom>
                <a:solidFill>
                  <a:srgbClr val="A50021"/>
                </a:solidFill>
                <a:ln>
                  <a:solidFill>
                    <a:srgbClr val="A5002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9" name="Textfeld 38"/>
                <p:cNvSpPr txBox="1"/>
                <p:nvPr/>
              </p:nvSpPr>
              <p:spPr>
                <a:xfrm>
                  <a:off x="9590194" y="6314919"/>
                  <a:ext cx="213221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ossibility</a:t>
                  </a:r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of</a:t>
                  </a:r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ejection</a:t>
                  </a:r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	</a:t>
                  </a:r>
                </a:p>
              </p:txBody>
            </p:sp>
          </p:grpSp>
          <p:pic>
            <p:nvPicPr>
              <p:cNvPr id="25" name="Grafik 24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-409575" y="32881"/>
                <a:ext cx="12930208" cy="6234413"/>
              </a:xfrm>
              <a:prstGeom prst="rect">
                <a:avLst/>
              </a:prstGeom>
            </p:spPr>
          </p:pic>
        </p:grpSp>
        <p:pic>
          <p:nvPicPr>
            <p:cNvPr id="23" name="Grafik 2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226263" y="2980266"/>
              <a:ext cx="303652" cy="106278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87114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>UK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ssig, Fabian</dc:creator>
  <cp:lastModifiedBy>Bhavna Deshwal</cp:lastModifiedBy>
  <cp:revision>8</cp:revision>
  <dcterms:created xsi:type="dcterms:W3CDTF">2022-08-01T13:48:39Z</dcterms:created>
  <dcterms:modified xsi:type="dcterms:W3CDTF">2022-10-03T11:25:55Z</dcterms:modified>
</cp:coreProperties>
</file>